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48"/>
  </p:normalViewPr>
  <p:slideViewPr>
    <p:cSldViewPr snapToGrid="0">
      <p:cViewPr varScale="1">
        <p:scale>
          <a:sx n="117" d="100"/>
          <a:sy n="117" d="100"/>
        </p:scale>
        <p:origin x="36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E50FB97-59C3-9801-F3B1-2F1C5E5F592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412507D2-BF3A-BD26-241B-2DDE55322CD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805C7EB-C237-E10D-57E6-F8ED27B662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130AE-BB1E-D94D-A571-8669F00D4792}" type="datetimeFigureOut">
              <a:rPr lang="fr-FR" smtClean="0"/>
              <a:t>17/1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CCC1727B-288F-B871-D67B-D60E31E49B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A8E803C-F512-B638-F7BA-FD54210FE2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E475F-0089-2848-BBC8-927ACCBD1B1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972611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CCC936D-C64C-F92A-F32E-AEB882B789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456EEFDA-688A-E60E-C2D4-E812A427AF4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58FDCB8-CAB0-C1C2-0334-205D51433A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130AE-BB1E-D94D-A571-8669F00D4792}" type="datetimeFigureOut">
              <a:rPr lang="fr-FR" smtClean="0"/>
              <a:t>17/1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B154619-0EB4-E7C6-13EA-9E745217B6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DE2E7DF-7510-EAFA-1AC4-CB3D858BC2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E475F-0089-2848-BBC8-927ACCBD1B1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528072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8B1A3C6D-C45C-4BF4-E077-3E2B2E1A2D2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1CBBCB2D-C83D-214D-1BBE-369EB76A87A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DC2FD79-7B5D-593F-A660-F4BDF29BF8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130AE-BB1E-D94D-A571-8669F00D4792}" type="datetimeFigureOut">
              <a:rPr lang="fr-FR" smtClean="0"/>
              <a:t>17/1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CB71ADA9-0BF7-D52C-40FF-E22890CA6F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592816F-A369-204D-3D08-4FD60994CB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E475F-0089-2848-BBC8-927ACCBD1B1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866891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639A2B9-D743-B318-96B3-821C0C6159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5D46C886-E528-F2E2-DEBE-D6BFDF06967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FAD60D8-37B5-F8F1-B4B9-E9137C163D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130AE-BB1E-D94D-A571-8669F00D4792}" type="datetimeFigureOut">
              <a:rPr lang="fr-FR" smtClean="0"/>
              <a:t>17/1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5671BA2-8120-A30D-CE0E-0867793F0C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231C925-8971-AC00-E44C-BEB6D61A6B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E475F-0089-2848-BBC8-927ACCBD1B1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130703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7E3EA42-0985-502D-DDD4-8EB1ABB4CA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9038E38-11FD-7DAB-DB9B-014EF6ED5E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9F60C22-C8C6-4167-5EA4-EB93D70311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130AE-BB1E-D94D-A571-8669F00D4792}" type="datetimeFigureOut">
              <a:rPr lang="fr-FR" smtClean="0"/>
              <a:t>17/1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A098F16-4CC2-11F2-A42B-86DA21D9BA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93DA3D0-A162-A267-B352-51F2E12F8A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E475F-0089-2848-BBC8-927ACCBD1B1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430255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4E0A2BD-D702-0D7A-993F-518E3243E1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5125502C-7D2D-B845-432C-63FB5B497ED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11BD176C-D9E0-8B03-9F9A-EEF5C1B3759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BB899C4E-84FF-106D-DA4B-00F5E36881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130AE-BB1E-D94D-A571-8669F00D4792}" type="datetimeFigureOut">
              <a:rPr lang="fr-FR" smtClean="0"/>
              <a:t>17/12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C7D73EAB-A4D0-96F9-5CD2-F8F07E66AA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24948087-B8AF-4D10-6E88-7F317459A1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E475F-0089-2848-BBC8-927ACCBD1B1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066350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E19BE0D-C7EB-8284-68EE-2AFB8EFB3B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A1587823-054A-C419-DE0E-EBFFCA96ED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5668B13B-01B3-DB2E-124B-E3EA0162CFC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636A9D15-1A97-526E-386A-94E5674D607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3AF2193B-B271-31CF-110C-BBC378A8D66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968BD5EB-FA5F-74BA-B870-2D76618C8D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130AE-BB1E-D94D-A571-8669F00D4792}" type="datetimeFigureOut">
              <a:rPr lang="fr-FR" smtClean="0"/>
              <a:t>17/12/2023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557308BA-9A0F-5BAE-383B-E153EFEBCE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41E3E959-83A0-617A-5E4F-09BA95D167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E475F-0089-2848-BBC8-927ACCBD1B1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694006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9624B53-4A30-9DB3-0EBD-3DA3002381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7C888AD3-85E3-F329-C68A-090B854AAA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130AE-BB1E-D94D-A571-8669F00D4792}" type="datetimeFigureOut">
              <a:rPr lang="fr-FR" smtClean="0"/>
              <a:t>17/12/2023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2748D538-CEA0-FD6F-B941-80953F4673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0A473E42-1E8C-A5BE-C10E-C64D2CB1C7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E475F-0089-2848-BBC8-927ACCBD1B1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137337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4A838A60-AAE2-43F3-E899-7925762CB2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130AE-BB1E-D94D-A571-8669F00D4792}" type="datetimeFigureOut">
              <a:rPr lang="fr-FR" smtClean="0"/>
              <a:t>17/12/2023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C3010EBF-73D1-BB63-BF5A-D7CF7FF677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8DEC05D2-A2AB-9B5F-B718-9CEAB17204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E475F-0089-2848-BBC8-927ACCBD1B1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517468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0AA00CF-CCBD-0A18-2991-3D048D82E0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239F6326-A9EE-11BA-BA03-F651C594F16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300EE507-EAF8-20BB-1540-37AB41942DA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B9284806-C043-51F2-B441-E3683112C3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130AE-BB1E-D94D-A571-8669F00D4792}" type="datetimeFigureOut">
              <a:rPr lang="fr-FR" smtClean="0"/>
              <a:t>17/12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04C0D3F5-77FC-04AF-C77B-E883D92E79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2F479A71-0A3C-CCA1-70E1-4806C36F80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E475F-0089-2848-BBC8-927ACCBD1B1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122188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59E888B-E045-22DC-7764-457183260F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C007CD5B-7E0B-945F-90DC-5A21BDB08CD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2C4764C1-3195-1D91-E094-5BCB1DCE2AA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5E60F94-355E-9CCC-9A6B-B2DE9BA884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130AE-BB1E-D94D-A571-8669F00D4792}" type="datetimeFigureOut">
              <a:rPr lang="fr-FR" smtClean="0"/>
              <a:t>17/12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C229ACE5-443B-75CB-B39F-BD64904A83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5CC919AC-2A3D-AA6F-9197-71318C8AFB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E475F-0089-2848-BBC8-927ACCBD1B1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222015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AE9C146B-E727-1E7C-1011-9EB86AC1FF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7D9A8295-2FEF-357D-1223-C4CBDAF15A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3CB0E53-E3E5-F447-E3F0-C258C13E6F5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7130AE-BB1E-D94D-A571-8669F00D4792}" type="datetimeFigureOut">
              <a:rPr lang="fr-FR" smtClean="0"/>
              <a:t>17/1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57F936F-DF66-DEB3-437E-962BCF32C04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BADCC39-044D-6047-2089-66BB88EC0D3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EE475F-0089-2848-BBC8-927ACCBD1B1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551035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49EAA2F8-3A8C-B6AD-ED3C-88BDCEA7771E}"/>
              </a:ext>
            </a:extLst>
          </p:cNvPr>
          <p:cNvSpPr txBox="1"/>
          <p:nvPr/>
        </p:nvSpPr>
        <p:spPr>
          <a:xfrm>
            <a:off x="137787" y="2627113"/>
            <a:ext cx="66075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3200" b="1" dirty="0"/>
              <a:t>(a)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39998221-91CB-6745-6CE1-3DFC1F6A17A5}"/>
              </a:ext>
            </a:extLst>
          </p:cNvPr>
          <p:cNvSpPr txBox="1"/>
          <p:nvPr/>
        </p:nvSpPr>
        <p:spPr>
          <a:xfrm>
            <a:off x="4496845" y="3657820"/>
            <a:ext cx="493853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400" b="1" dirty="0" err="1"/>
              <a:t>Glycoproteins</a:t>
            </a:r>
            <a:r>
              <a:rPr lang="fr-FR" sz="2400" b="1" dirty="0"/>
              <a:t> </a:t>
            </a:r>
            <a:r>
              <a:rPr lang="fr-FR" sz="2400" b="1" dirty="0" err="1"/>
              <a:t>precursor</a:t>
            </a:r>
            <a:r>
              <a:rPr lang="fr-FR" sz="2400" b="1" dirty="0"/>
              <a:t> (M segment)</a:t>
            </a:r>
          </a:p>
        </p:txBody>
      </p:sp>
      <p:pic>
        <p:nvPicPr>
          <p:cNvPr id="6" name="Image 5">
            <a:extLst>
              <a:ext uri="{FF2B5EF4-FFF2-40B4-BE49-F238E27FC236}">
                <a16:creationId xmlns:a16="http://schemas.microsoft.com/office/drawing/2014/main" id="{91D8CE5B-D5CC-E227-7398-0C89F2DF8C3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235" t="47829" r="54055"/>
          <a:stretch/>
        </p:blipFill>
        <p:spPr>
          <a:xfrm>
            <a:off x="0" y="4144830"/>
            <a:ext cx="3920647" cy="2745328"/>
          </a:xfrm>
          <a:prstGeom prst="rect">
            <a:avLst/>
          </a:prstGeom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id="{629F3CAC-01EA-2141-BDF5-41C12D6FF4A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8255" r="3672" b="51377"/>
          <a:stretch/>
        </p:blipFill>
        <p:spPr>
          <a:xfrm>
            <a:off x="3813322" y="4468439"/>
            <a:ext cx="8178716" cy="2010745"/>
          </a:xfrm>
          <a:prstGeom prst="rect">
            <a:avLst/>
          </a:prstGeom>
        </p:spPr>
      </p:pic>
      <p:sp>
        <p:nvSpPr>
          <p:cNvPr id="8" name="Cadre 7">
            <a:extLst>
              <a:ext uri="{FF2B5EF4-FFF2-40B4-BE49-F238E27FC236}">
                <a16:creationId xmlns:a16="http://schemas.microsoft.com/office/drawing/2014/main" id="{E85A48DD-B22D-D3A7-B2E6-00EFAD4F1CC9}"/>
              </a:ext>
            </a:extLst>
          </p:cNvPr>
          <p:cNvSpPr/>
          <p:nvPr/>
        </p:nvSpPr>
        <p:spPr>
          <a:xfrm>
            <a:off x="9834982" y="4141194"/>
            <a:ext cx="2156602" cy="2242159"/>
          </a:xfrm>
          <a:prstGeom prst="frame">
            <a:avLst>
              <a:gd name="adj1" fmla="val 5647"/>
            </a:avLst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solidFill>
                <a:schemeClr val="tx1"/>
              </a:solidFill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D0957AE9-3DF4-A74E-D690-E854B666DBF1}"/>
              </a:ext>
            </a:extLst>
          </p:cNvPr>
          <p:cNvSpPr txBox="1"/>
          <p:nvPr/>
        </p:nvSpPr>
        <p:spPr>
          <a:xfrm>
            <a:off x="137787" y="1655596"/>
            <a:ext cx="9198429" cy="56194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FI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1 Appendix: Frequencies of amino-acids of the query set and background set sequences</a:t>
            </a:r>
            <a:endParaRPr lang="en-FI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7E47290-88D2-EA16-8B16-6A43E9E53FA7}"/>
              </a:ext>
            </a:extLst>
          </p:cNvPr>
          <p:cNvSpPr txBox="1"/>
          <p:nvPr/>
        </p:nvSpPr>
        <p:spPr>
          <a:xfrm>
            <a:off x="151995" y="-72741"/>
            <a:ext cx="11408634" cy="139493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volution and Genetic Characterization of Seoul Virus in Wild Rats </a:t>
            </a:r>
            <a:r>
              <a:rPr lang="en-US" sz="1100" b="1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attus Norvegicus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rom an urban park in Lyon, France 2020-2022</a:t>
            </a:r>
            <a:endParaRPr lang="en-FI" sz="11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hort Title: Seoul virus in wild rats from an urban park</a:t>
            </a:r>
            <a:endParaRPr lang="en-FI" sz="110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uthors : </a:t>
            </a:r>
            <a:r>
              <a:rPr lang="en-US" sz="11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lburkat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Hussein, </a:t>
            </a:r>
            <a:r>
              <a:rPr lang="en-US" sz="11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mura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1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eemu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</a:t>
            </a:r>
            <a:r>
              <a:rPr lang="en-US" sz="11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ouilloud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Marie, </a:t>
            </a:r>
            <a:r>
              <a:rPr lang="en-US" sz="11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radel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Julien, </a:t>
            </a:r>
            <a:r>
              <a:rPr lang="en-US" sz="11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nfray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Gwendoline, Berthier </a:t>
            </a:r>
            <a:r>
              <a:rPr lang="en-US" sz="11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Karine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Dutra Lara, Loiseau Anne, </a:t>
            </a:r>
            <a:r>
              <a:rPr lang="en-US" sz="11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Niamsap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1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hanakorn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Olander, Viktor, Sepulveda Diana, Venkat Vinaya, </a:t>
            </a:r>
            <a:r>
              <a:rPr lang="en-US" sz="11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harbonnel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Nathalie, Castel Guillaume, </a:t>
            </a:r>
            <a:r>
              <a:rPr lang="en-US" sz="11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ironen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1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arja</a:t>
            </a:r>
            <a:endParaRPr lang="en-FI" sz="11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5861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>
            <a:extLst>
              <a:ext uri="{FF2B5EF4-FFF2-40B4-BE49-F238E27FC236}">
                <a16:creationId xmlns:a16="http://schemas.microsoft.com/office/drawing/2014/main" id="{DE192D8F-0CD4-D344-9E53-2EFF187CD8F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47245" r="54813"/>
          <a:stretch/>
        </p:blipFill>
        <p:spPr>
          <a:xfrm>
            <a:off x="526094" y="1611899"/>
            <a:ext cx="3369502" cy="2830752"/>
          </a:xfrm>
          <a:prstGeom prst="rect">
            <a:avLst/>
          </a:prstGeom>
        </p:spPr>
      </p:pic>
      <p:pic>
        <p:nvPicPr>
          <p:cNvPr id="5" name="Image 4">
            <a:extLst>
              <a:ext uri="{FF2B5EF4-FFF2-40B4-BE49-F238E27FC236}">
                <a16:creationId xmlns:a16="http://schemas.microsoft.com/office/drawing/2014/main" id="{C1E0CB29-05AD-2CF0-CAF3-4621364993A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8196" b="52239"/>
          <a:stretch/>
        </p:blipFill>
        <p:spPr>
          <a:xfrm>
            <a:off x="3794950" y="1868618"/>
            <a:ext cx="8139335" cy="2317314"/>
          </a:xfrm>
          <a:prstGeom prst="rect">
            <a:avLst/>
          </a:prstGeom>
        </p:spPr>
      </p:pic>
      <p:sp>
        <p:nvSpPr>
          <p:cNvPr id="6" name="ZoneTexte 5">
            <a:extLst>
              <a:ext uri="{FF2B5EF4-FFF2-40B4-BE49-F238E27FC236}">
                <a16:creationId xmlns:a16="http://schemas.microsoft.com/office/drawing/2014/main" id="{147D89D8-97CD-B5BD-027A-B1DF3D57F953}"/>
              </a:ext>
            </a:extLst>
          </p:cNvPr>
          <p:cNvSpPr txBox="1"/>
          <p:nvPr/>
        </p:nvSpPr>
        <p:spPr>
          <a:xfrm>
            <a:off x="6212910" y="1278593"/>
            <a:ext cx="241957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400" b="1" dirty="0" err="1"/>
              <a:t>RdRP</a:t>
            </a:r>
            <a:r>
              <a:rPr lang="fr-FR" sz="2400" b="1" dirty="0"/>
              <a:t> (L segment)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56FC256B-4B9D-7A7D-6907-E2EB9F93D1A7}"/>
              </a:ext>
            </a:extLst>
          </p:cNvPr>
          <p:cNvSpPr txBox="1"/>
          <p:nvPr/>
        </p:nvSpPr>
        <p:spPr>
          <a:xfrm>
            <a:off x="288099" y="538619"/>
            <a:ext cx="66075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3200" b="1" dirty="0"/>
              <a:t>(b)</a:t>
            </a:r>
          </a:p>
        </p:txBody>
      </p:sp>
      <p:sp>
        <p:nvSpPr>
          <p:cNvPr id="8" name="Cadre 7">
            <a:extLst>
              <a:ext uri="{FF2B5EF4-FFF2-40B4-BE49-F238E27FC236}">
                <a16:creationId xmlns:a16="http://schemas.microsoft.com/office/drawing/2014/main" id="{1A38531A-63CF-F9D5-B5E9-0D026A11DF37}"/>
              </a:ext>
            </a:extLst>
          </p:cNvPr>
          <p:cNvSpPr/>
          <p:nvPr/>
        </p:nvSpPr>
        <p:spPr>
          <a:xfrm>
            <a:off x="8632483" y="1740258"/>
            <a:ext cx="774564" cy="2593747"/>
          </a:xfrm>
          <a:prstGeom prst="frame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solidFill>
                <a:schemeClr val="tx1"/>
              </a:solidFill>
            </a:endParaRPr>
          </a:p>
        </p:txBody>
      </p:sp>
      <p:sp>
        <p:nvSpPr>
          <p:cNvPr id="9" name="Cadre 8">
            <a:extLst>
              <a:ext uri="{FF2B5EF4-FFF2-40B4-BE49-F238E27FC236}">
                <a16:creationId xmlns:a16="http://schemas.microsoft.com/office/drawing/2014/main" id="{27BDD4B1-1A32-3AC9-7333-12545BB24E65}"/>
              </a:ext>
            </a:extLst>
          </p:cNvPr>
          <p:cNvSpPr/>
          <p:nvPr/>
        </p:nvSpPr>
        <p:spPr>
          <a:xfrm>
            <a:off x="10175233" y="1740258"/>
            <a:ext cx="774564" cy="2593747"/>
          </a:xfrm>
          <a:prstGeom prst="frame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0221819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111</Words>
  <Application>Microsoft Macintosh PowerPoint</Application>
  <PresentationFormat>Widescreen</PresentationFormat>
  <Paragraphs>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hème Offic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icrosoft Office User</dc:creator>
  <cp:lastModifiedBy>Alburkat, Hussein</cp:lastModifiedBy>
  <cp:revision>6</cp:revision>
  <dcterms:created xsi:type="dcterms:W3CDTF">2023-04-12T07:17:10Z</dcterms:created>
  <dcterms:modified xsi:type="dcterms:W3CDTF">2023-12-17T06:36:41Z</dcterms:modified>
</cp:coreProperties>
</file>